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0" autoAdjust="0"/>
    <p:restoredTop sz="94660"/>
  </p:normalViewPr>
  <p:slideViewPr>
    <p:cSldViewPr snapToGrid="0">
      <p:cViewPr varScale="1">
        <p:scale>
          <a:sx n="80" d="100"/>
          <a:sy n="80" d="100"/>
        </p:scale>
        <p:origin x="4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5778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8550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720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1178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8560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7043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2177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6832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8420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6769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0671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C2BDB-0B1B-43DC-960C-EE5F58FE3EE6}" type="datetimeFigureOut">
              <a:rPr lang="fr-FR" smtClean="0"/>
              <a:t>22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17E42-C725-4BC1-ABE3-3C3C7A72AA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9776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lvl="0" eaLnBrk="0" fontAlgn="base" hangingPunct="0">
              <a:lnSpc>
                <a:spcPct val="100000"/>
              </a:lnSpc>
              <a:spcAft>
                <a:spcPct val="0"/>
              </a:spcAft>
            </a:pPr>
            <a:r>
              <a:rPr lang="fr-FR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fr-FR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2: </a:t>
            </a:r>
            <a:r>
              <a:rPr lang="en-AU" altLang="fr-F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agnostics for spatial regression modelling</a:t>
            </a:r>
            <a:endParaRPr kumimoji="0" lang="fr-FR" altLang="fr-FR" sz="2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4" name="Espace réservé du contenu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52534302"/>
              </p:ext>
            </p:extLst>
          </p:nvPr>
        </p:nvGraphicFramePr>
        <p:xfrm>
          <a:off x="2546279" y="2549699"/>
          <a:ext cx="6306207" cy="2664373"/>
        </p:xfrm>
        <a:graphic>
          <a:graphicData uri="http://schemas.openxmlformats.org/drawingml/2006/table">
            <a:tbl>
              <a:tblPr firstRow="1" firstCol="1" bandRow="1"/>
              <a:tblGrid>
                <a:gridCol w="3676757">
                  <a:extLst>
                    <a:ext uri="{9D8B030D-6E8A-4147-A177-3AD203B41FA5}">
                      <a16:colId xmlns:a16="http://schemas.microsoft.com/office/drawing/2014/main" val="3219120213"/>
                    </a:ext>
                  </a:extLst>
                </a:gridCol>
                <a:gridCol w="1234232">
                  <a:extLst>
                    <a:ext uri="{9D8B030D-6E8A-4147-A177-3AD203B41FA5}">
                      <a16:colId xmlns:a16="http://schemas.microsoft.com/office/drawing/2014/main" val="672510319"/>
                    </a:ext>
                  </a:extLst>
                </a:gridCol>
                <a:gridCol w="1395218">
                  <a:extLst>
                    <a:ext uri="{9D8B030D-6E8A-4147-A177-3AD203B41FA5}">
                      <a16:colId xmlns:a16="http://schemas.microsoft.com/office/drawing/2014/main" val="4271596974"/>
                    </a:ext>
                  </a:extLst>
                </a:gridCol>
              </a:tblGrid>
              <a:tr h="936037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st </a:t>
                      </a:r>
                      <a:endParaRPr lang="fr-FR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dicators statistics </a:t>
                      </a:r>
                      <a:endParaRPr lang="fr-FR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fr-FR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9421555"/>
                  </a:ext>
                </a:extLst>
              </a:tr>
              <a:tr h="43208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agrange multiplier (LM)-lag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.2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487436"/>
                  </a:ext>
                </a:extLst>
              </a:tr>
              <a:tr h="43208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obust LM-lag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82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8464895"/>
                  </a:ext>
                </a:extLst>
              </a:tr>
              <a:tr h="43208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M-error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80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5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8528399"/>
                  </a:ext>
                </a:extLst>
              </a:tr>
              <a:tr h="43208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obust LM-error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1000"/>
                        </a:spcAft>
                      </a:pPr>
                      <a:r>
                        <a:rPr lang="en-AU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00907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92473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Supplementary table 2: Diagnostics for spatial regression modelling</vt:lpstr>
    </vt:vector>
  </TitlesOfParts>
  <Company>EHES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table 2: Diagnostics for spatial regression modelling</dc:title>
  <dc:creator>Padilla, Cindy</dc:creator>
  <cp:lastModifiedBy>Padilla, Cindy</cp:lastModifiedBy>
  <cp:revision>2</cp:revision>
  <dcterms:created xsi:type="dcterms:W3CDTF">2022-11-18T13:50:06Z</dcterms:created>
  <dcterms:modified xsi:type="dcterms:W3CDTF">2022-11-22T12:02:30Z</dcterms:modified>
</cp:coreProperties>
</file>